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34" r:id="rId2"/>
    <p:sldId id="332" r:id="rId3"/>
    <p:sldId id="307" r:id="rId4"/>
    <p:sldId id="306" r:id="rId5"/>
    <p:sldId id="333" r:id="rId6"/>
    <p:sldId id="323" r:id="rId7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771" autoAdjust="0"/>
    <p:restoredTop sz="94660"/>
  </p:normalViewPr>
  <p:slideViewPr>
    <p:cSldViewPr>
      <p:cViewPr>
        <p:scale>
          <a:sx n="80" d="100"/>
          <a:sy n="80" d="100"/>
        </p:scale>
        <p:origin x="-2478" y="-74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4" Type="http://schemas.openxmlformats.org/officeDocument/2006/relationships/image" Target="../media/image7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81FDD8-E44D-423D-ABCC-5704562943C1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CH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029609-158A-4205-A93B-371BE1F7022C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987480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029609-158A-4205-A93B-371BE1F7022C}" type="slidenum">
              <a:rPr lang="de-CH" smtClean="0"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237631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029609-158A-4205-A93B-371BE1F7022C}" type="slidenum">
              <a:rPr lang="de-CH" smtClean="0"/>
              <a:t>2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237631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029609-158A-4205-A93B-371BE1F7022C}" type="slidenum">
              <a:rPr lang="de-CH" smtClean="0"/>
              <a:t>3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2376313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029609-158A-4205-A93B-371BE1F7022C}" type="slidenum">
              <a:rPr lang="de-CH" smtClean="0"/>
              <a:t>4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2376313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029609-158A-4205-A93B-371BE1F7022C}" type="slidenum">
              <a:rPr lang="de-CH" smtClean="0"/>
              <a:t>5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2376313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029609-158A-4205-A93B-371BE1F7022C}" type="slidenum">
              <a:rPr lang="de-CH" smtClean="0"/>
              <a:t>6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237631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778668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1144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652102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47092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38106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93361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3026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699462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263962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7837879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23664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57C9D-6B8C-434F-BFC4-0CE2633EBD99}" type="datetimeFigureOut">
              <a:rPr lang="de-CH" smtClean="0"/>
              <a:t>03.04.2015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FA762C-574A-4DC1-9A8A-5D742EDCC94A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60460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5.emf"/><Relationship Id="rId12" Type="http://schemas.openxmlformats.org/officeDocument/2006/relationships/image" Target="../media/image8.png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11" Type="http://schemas.openxmlformats.org/officeDocument/2006/relationships/image" Target="../media/image7.emf"/><Relationship Id="rId5" Type="http://schemas.openxmlformats.org/officeDocument/2006/relationships/image" Target="../media/image4.emf"/><Relationship Id="rId10" Type="http://schemas.openxmlformats.org/officeDocument/2006/relationships/oleObject" Target="../embeddings/oleObject6.bin"/><Relationship Id="rId4" Type="http://schemas.openxmlformats.org/officeDocument/2006/relationships/oleObject" Target="../embeddings/oleObject3.bin"/><Relationship Id="rId9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7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7" Type="http://schemas.openxmlformats.org/officeDocument/2006/relationships/image" Target="../media/image1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11.emf"/><Relationship Id="rId4" Type="http://schemas.openxmlformats.org/officeDocument/2006/relationships/oleObject" Target="../embeddings/oleObject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11560" y="5374957"/>
            <a:ext cx="79928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ementary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 [</a:t>
            </a:r>
            <a:r>
              <a:rPr lang="en-GB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]GTP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ays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formed in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ck transfected CHO cells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CP55,940, AM630, MH and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a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tested in [</a:t>
            </a:r>
            <a:r>
              <a:rPr lang="en-GB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]GT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ays using 20 µg of membranes obtained from  mock-transfected CHO cells at concentrations of 1 and 10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. The level of basal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[</a:t>
            </a:r>
            <a:r>
              <a:rPr lang="en-GB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]GTP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binding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CHO-</a:t>
            </a:r>
            <a:r>
              <a:rPr lang="en-GB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B</a:t>
            </a:r>
            <a:r>
              <a:rPr lang="en-GB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is also reported as a reference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1452" name="Picture 1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09825" y="908720"/>
            <a:ext cx="4324350" cy="3990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24637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1835696" y="1166267"/>
            <a:ext cx="5331644" cy="3291433"/>
            <a:chOff x="1835696" y="1166267"/>
            <a:chExt cx="5331644" cy="3291433"/>
          </a:xfrm>
        </p:grpSpPr>
        <p:graphicFrame>
          <p:nvGraphicFramePr>
            <p:cNvPr id="13" name="Object 1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7245011"/>
                </p:ext>
              </p:extLst>
            </p:nvPr>
          </p:nvGraphicFramePr>
          <p:xfrm>
            <a:off x="1835696" y="1560513"/>
            <a:ext cx="2362200" cy="28971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6425" name="Prism 5" r:id="rId4" imgW="2362320" imgH="2897280" progId="Prism5.Document">
                    <p:embed/>
                  </p:oleObj>
                </mc:Choice>
                <mc:Fallback>
                  <p:oleObj name="Prism 5" r:id="rId4" imgW="2362320" imgH="289728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835696" y="1560513"/>
                          <a:ext cx="2362200" cy="289718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4" name="Object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76064545"/>
                </p:ext>
              </p:extLst>
            </p:nvPr>
          </p:nvGraphicFramePr>
          <p:xfrm>
            <a:off x="4752752" y="1641475"/>
            <a:ext cx="2414588" cy="27971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6426" name="Prism 5" r:id="rId6" imgW="2414160" imgH="2796480" progId="Prism5.Document">
                    <p:embed/>
                  </p:oleObj>
                </mc:Choice>
                <mc:Fallback>
                  <p:oleObj name="Prism 5" r:id="rId6" imgW="2414160" imgH="279648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4752752" y="1641475"/>
                          <a:ext cx="2414588" cy="27971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15"/>
            <p:cNvSpPr txBox="1"/>
            <p:nvPr/>
          </p:nvSpPr>
          <p:spPr>
            <a:xfrm>
              <a:off x="2838877" y="1177007"/>
              <a:ext cx="7617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M630</a:t>
              </a:r>
              <a:endParaRPr lang="de-CH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472832" y="1166267"/>
              <a:ext cx="98135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P55,940</a:t>
              </a:r>
              <a:endParaRPr lang="de-CH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323528" y="5118283"/>
            <a:ext cx="84249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.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rmacological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ehaviour of AM630 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P55,940 in presence or absence 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itutive 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y 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CB</a:t>
            </a:r>
            <a:r>
              <a:rPr lang="de-CH" sz="1200" b="1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eptors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In presence of constitutive activity, AM630 increased forskolin-induced cAMP production while this effect is abolished upon 24 h pre-treatment with 10 µM of AM630 (CB</a:t>
            </a:r>
            <a:r>
              <a:rPr lang="de-CH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receptors in the inactive state). The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P55,940 on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MP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ot affected by the presence or absence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stitutively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tivated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B</a:t>
            </a:r>
            <a:r>
              <a:rPr lang="de-CH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ceptors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C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081117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79512" y="5877272"/>
            <a:ext cx="880247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. The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DuP-697 in different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ular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ystems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The non-selective COX-2 inhibitor DuP-697 showed the same potency of inhibiting PGE</a:t>
            </a:r>
            <a:r>
              <a:rPr lang="de-CH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PGE</a:t>
            </a:r>
            <a:r>
              <a:rPr lang="de-CH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GE formation in (A) purified </a:t>
            </a:r>
            <a:r>
              <a:rPr lang="de-CH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X-2, (B) RAW264.7 cell homogenate and (C) intact cells. (D) Chromatograms of PGE</a:t>
            </a:r>
            <a:r>
              <a:rPr lang="de-CH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PGE</a:t>
            </a:r>
            <a:r>
              <a:rPr lang="de-CH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GE formation in 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W264.7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act cells. (E) DuP-697 retained the non selective inhibition of COX-2 activity also in RAW264.7 cells stimulated to endogenously produce 2-AG. </a:t>
            </a:r>
            <a:endParaRPr lang="de-C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361529" y="188640"/>
            <a:ext cx="8386935" cy="5551095"/>
            <a:chOff x="361529" y="188640"/>
            <a:chExt cx="8386935" cy="5551095"/>
          </a:xfrm>
        </p:grpSpPr>
        <p:graphicFrame>
          <p:nvGraphicFramePr>
            <p:cNvPr id="5" name="Object 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13842520"/>
                </p:ext>
              </p:extLst>
            </p:nvPr>
          </p:nvGraphicFramePr>
          <p:xfrm>
            <a:off x="6071939" y="609810"/>
            <a:ext cx="2676525" cy="2584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546" name="Prism 5" r:id="rId4" imgW="2675880" imgH="2584800" progId="Prism5.Document">
                    <p:embed/>
                  </p:oleObj>
                </mc:Choice>
                <mc:Fallback>
                  <p:oleObj name="Prism 5" r:id="rId4" imgW="2675880" imgH="25848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071939" y="609810"/>
                          <a:ext cx="2676525" cy="25844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9525">
                              <a:solidFill>
                                <a:srgbClr val="000000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656019349"/>
                </p:ext>
              </p:extLst>
            </p:nvPr>
          </p:nvGraphicFramePr>
          <p:xfrm>
            <a:off x="361529" y="617980"/>
            <a:ext cx="2554287" cy="2582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547" name="Prism 5" r:id="rId6" imgW="2554200" imgH="2583360" progId="Prism5.Document">
                    <p:embed/>
                  </p:oleObj>
                </mc:Choice>
                <mc:Fallback>
                  <p:oleObj name="Prism 5" r:id="rId6" imgW="2554200" imgH="258336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61529" y="617980"/>
                          <a:ext cx="2554287" cy="2582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57347269"/>
                </p:ext>
              </p:extLst>
            </p:nvPr>
          </p:nvGraphicFramePr>
          <p:xfrm>
            <a:off x="3563888" y="609036"/>
            <a:ext cx="2676525" cy="25828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548" name="Prism 5" r:id="rId8" imgW="2675880" imgH="2583360" progId="Prism5.Document">
                    <p:embed/>
                  </p:oleObj>
                </mc:Choice>
                <mc:Fallback>
                  <p:oleObj name="Prism 5" r:id="rId8" imgW="2675880" imgH="258336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563888" y="609036"/>
                          <a:ext cx="2676525" cy="25828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7048629" y="515762"/>
              <a:ext cx="9797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act cells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343976" y="520019"/>
              <a:ext cx="14253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ell homogenate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115616" y="518585"/>
              <a:ext cx="7489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12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r>
                <a:rPr lang="de-CH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X-2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677056" y="188640"/>
              <a:ext cx="10516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AW264.7</a:t>
              </a:r>
              <a:endParaRPr lang="de-CH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Straight Connector 13"/>
            <p:cNvCxnSpPr/>
            <p:nvPr/>
          </p:nvCxnSpPr>
          <p:spPr>
            <a:xfrm>
              <a:off x="3707904" y="503866"/>
              <a:ext cx="4608512" cy="0"/>
            </a:xfrm>
            <a:prstGeom prst="line">
              <a:avLst/>
            </a:prstGeom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graphicFrame>
          <p:nvGraphicFramePr>
            <p:cNvPr id="15" name="Object 1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90272897"/>
                </p:ext>
              </p:extLst>
            </p:nvPr>
          </p:nvGraphicFramePr>
          <p:xfrm>
            <a:off x="6078538" y="3118773"/>
            <a:ext cx="2447925" cy="26209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9549" name="Prism 5" r:id="rId10" imgW="2472120" imgH="2647440" progId="Prism5.Document">
                    <p:embed/>
                  </p:oleObj>
                </mc:Choice>
                <mc:Fallback>
                  <p:oleObj name="Prism 5" r:id="rId10" imgW="2472120" imgH="264744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11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078538" y="3118773"/>
                          <a:ext cx="2447925" cy="26209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xtLst/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16" name="Picture 15"/>
            <p:cNvPicPr>
              <a:picLocks noChangeAspect="1"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4282"/>
            <a:stretch/>
          </p:blipFill>
          <p:spPr>
            <a:xfrm>
              <a:off x="492915" y="3571041"/>
              <a:ext cx="5240019" cy="1971950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384903" y="528316"/>
              <a:ext cx="3240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de-CH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585154" y="528316"/>
              <a:ext cx="3240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de-CH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105434" y="528316"/>
              <a:ext cx="3240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de-CH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95536" y="3046194"/>
              <a:ext cx="3240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de-CH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145543" y="3046194"/>
              <a:ext cx="32403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CH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de-CH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551444" y="3272851"/>
              <a:ext cx="126509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-AG oxygenation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499667" y="3272851"/>
              <a:ext cx="11304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CH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A oxygena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42762742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323528" y="5949280"/>
            <a:ext cx="86409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4. LC-MS/MS 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cation of </a:t>
            </a:r>
            <a:r>
              <a:rPr lang="de-CH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acetylethanolamines in 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use brai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lmitoyl-, linoleoyl-, stearoyl-, oleoyl ethanolamides and NA-GABA were 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fied in brains from mice challenged for 6 h with LPS (i.p., 2.5 mg kg</a:t>
            </a:r>
            <a:r>
              <a:rPr lang="de-CH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or saline), after 1 h of pre-treatment with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H (</a:t>
            </a:r>
            <a:r>
              <a:rPr lang="de-CH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.p</a:t>
            </a:r>
            <a:r>
              <a:rPr lang="de-CH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3, 10 and 20 mg kg</a:t>
            </a:r>
            <a:r>
              <a:rPr lang="de-CH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r vehicle. </a:t>
            </a:r>
          </a:p>
        </p:txBody>
      </p:sp>
      <p:pic>
        <p:nvPicPr>
          <p:cNvPr id="41393" name="Picture 43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332656"/>
            <a:ext cx="7313613" cy="5553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6055450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5478323"/>
            <a:ext cx="864096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. [</a:t>
            </a:r>
            <a:r>
              <a:rPr lang="de-CH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]AEA uptake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o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937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-derived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crophages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Different concentrations of MH and 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2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ere pre-incubated for 15 min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U937 </a:t>
            </a:r>
            <a:r>
              <a:rPr lang="de-CH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-derived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acrophages and then cells were incubated for 5 min with 100 nM of [</a:t>
            </a:r>
            <a:r>
              <a:rPr lang="de-CH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]AEA. UCM707 was used as positve control. The radioactivity associated with the liphophilic fraction extracted from cells was expressd in % of vehicle-treated cells.</a:t>
            </a:r>
            <a:endParaRPr lang="de-C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1403166"/>
              </p:ext>
            </p:extLst>
          </p:nvPr>
        </p:nvGraphicFramePr>
        <p:xfrm>
          <a:off x="3203848" y="1475883"/>
          <a:ext cx="3240360" cy="36051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0427" name="Prism 5" r:id="rId4" imgW="2383560" imgH="2651760" progId="Prism5.Document">
                  <p:embed/>
                </p:oleObj>
              </mc:Choice>
              <mc:Fallback>
                <p:oleObj name="Prism 5" r:id="rId4" imgW="2383560" imgH="26517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203848" y="1475883"/>
                        <a:ext cx="3240360" cy="36051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75362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51520" y="5818186"/>
            <a:ext cx="86409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6. Screening of several MHK, honokiol and magnolol derivaitves for SSI of COX-2 activity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A) Screening of the library at 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 µM using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-AG (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µM)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 </a:t>
            </a:r>
            <a:r>
              <a:rPr lang="de-CH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X-2 substrate. (B) </a:t>
            </a:r>
            <a:r>
              <a:rPr lang="de-CH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X-2 was added to 10 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AA or 2-AG after 30 min pre-treatment with 2 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M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the hit compounds, vehicle or the positive control (DuP-697). *p&lt;0.05, **p&lt;0.01 2-AG substrate </a:t>
            </a:r>
            <a:r>
              <a:rPr lang="de-CH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.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A substrate</a:t>
            </a:r>
            <a:endParaRPr lang="de-CH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1050925" y="404664"/>
            <a:ext cx="6977063" cy="5207793"/>
            <a:chOff x="1050925" y="404664"/>
            <a:chExt cx="6977063" cy="5207793"/>
          </a:xfrm>
        </p:grpSpPr>
        <p:graphicFrame>
          <p:nvGraphicFramePr>
            <p:cNvPr id="2" name="Object 1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53172554"/>
                </p:ext>
              </p:extLst>
            </p:nvPr>
          </p:nvGraphicFramePr>
          <p:xfrm>
            <a:off x="2354511" y="3338819"/>
            <a:ext cx="4233713" cy="22736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0274" name="Prism 5" r:id="rId4" imgW="4447080" imgH="2388240" progId="Prism5.Document">
                    <p:embed/>
                  </p:oleObj>
                </mc:Choice>
                <mc:Fallback>
                  <p:oleObj name="Prism 5" r:id="rId4" imgW="4447080" imgH="238824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354511" y="3338819"/>
                          <a:ext cx="4233713" cy="22736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48647593"/>
                </p:ext>
              </p:extLst>
            </p:nvPr>
          </p:nvGraphicFramePr>
          <p:xfrm>
            <a:off x="1050925" y="404664"/>
            <a:ext cx="6977063" cy="29670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0275" name="Prism 5" r:id="rId6" imgW="6976800" imgH="2967120" progId="Prism5.Document">
                    <p:embed/>
                  </p:oleObj>
                </mc:Choice>
                <mc:Fallback>
                  <p:oleObj name="Prism 5" r:id="rId6" imgW="6976800" imgH="296712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050925" y="404664"/>
                          <a:ext cx="6977063" cy="29670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/>
            <p:cNvSpPr txBox="1"/>
            <p:nvPr/>
          </p:nvSpPr>
          <p:spPr>
            <a:xfrm>
              <a:off x="1115616" y="457498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400" b="1" dirty="0" smtClean="0"/>
                <a:t>A</a:t>
              </a:r>
              <a:endParaRPr lang="de-CH" sz="14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411760" y="3236193"/>
              <a:ext cx="28565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CH" sz="1400" b="1" dirty="0" smtClean="0"/>
                <a:t>B</a:t>
              </a:r>
              <a:endParaRPr lang="de-CH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2955643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6</Words>
  <Application>Microsoft Office PowerPoint</Application>
  <PresentationFormat>Bildschirmpräsentation (4:3)</PresentationFormat>
  <Paragraphs>27</Paragraphs>
  <Slides>6</Slides>
  <Notes>6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8" baseType="lpstr">
      <vt:lpstr>Office Theme</vt:lpstr>
      <vt:lpstr>Prism 5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icca Andrea</dc:creator>
  <cp:lastModifiedBy>Jürg</cp:lastModifiedBy>
  <cp:revision>233</cp:revision>
  <dcterms:created xsi:type="dcterms:W3CDTF">2014-04-01T15:50:24Z</dcterms:created>
  <dcterms:modified xsi:type="dcterms:W3CDTF">2015-04-03T08:14:49Z</dcterms:modified>
</cp:coreProperties>
</file>